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029200" cy="5029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47835E-18AE-4A31-829A-0254915F0E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50920" y="201600"/>
            <a:ext cx="4527360" cy="838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50920" y="1172880"/>
            <a:ext cx="452736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50920" y="2907000"/>
            <a:ext cx="452736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D1A4E8-2597-4C3A-A22D-0F9DD531F2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50920" y="201600"/>
            <a:ext cx="4527360" cy="838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50920" y="1172880"/>
            <a:ext cx="220932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571120" y="1172880"/>
            <a:ext cx="220932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50920" y="2907000"/>
            <a:ext cx="220932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571120" y="2907000"/>
            <a:ext cx="220932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51C7AE-B35D-4628-B854-8F4C45B88F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50920" y="201600"/>
            <a:ext cx="4527360" cy="838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50920" y="1172880"/>
            <a:ext cx="145764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782000" y="1172880"/>
            <a:ext cx="145764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312720" y="1172880"/>
            <a:ext cx="145764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50920" y="2907000"/>
            <a:ext cx="145764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782000" y="2907000"/>
            <a:ext cx="145764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312720" y="2907000"/>
            <a:ext cx="145764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EFDB2-EA32-47A6-88E8-E8EC703618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50920" y="201600"/>
            <a:ext cx="4527360" cy="838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50920" y="1172880"/>
            <a:ext cx="4527360" cy="331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24"/>
              </a:spcBef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2B91F-B2F6-4651-9D36-704DD77F83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50920" y="201600"/>
            <a:ext cx="4527360" cy="838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50920" y="1172880"/>
            <a:ext cx="4527360" cy="3319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919433-9085-4A6B-BBA0-6946AB6B9A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50920" y="201600"/>
            <a:ext cx="4527360" cy="838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50920" y="1172880"/>
            <a:ext cx="2209320" cy="3319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571120" y="1172880"/>
            <a:ext cx="2209320" cy="3319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2BA73-BC9F-4506-9101-4EAED40CC6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50920" y="201600"/>
            <a:ext cx="4527360" cy="838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39500-2051-4D15-962E-FE1D350FE6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50920" y="201600"/>
            <a:ext cx="4527360" cy="388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24"/>
              </a:spcBef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B1FEF-33D2-4461-A1CA-1AFA26BC86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50920" y="201600"/>
            <a:ext cx="4527360" cy="838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50920" y="1172880"/>
            <a:ext cx="220932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571120" y="1172880"/>
            <a:ext cx="2209320" cy="3319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50920" y="2907000"/>
            <a:ext cx="220932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966C6-54E7-485E-8B81-A32EE7E4E3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50920" y="201600"/>
            <a:ext cx="4527360" cy="838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50920" y="1172880"/>
            <a:ext cx="2209320" cy="3319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571120" y="1172880"/>
            <a:ext cx="220932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571120" y="2907000"/>
            <a:ext cx="220932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BAADEA-C850-4AB2-A42F-79BBB8FFED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50920" y="201600"/>
            <a:ext cx="4527360" cy="838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50920" y="1172880"/>
            <a:ext cx="220932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571120" y="1172880"/>
            <a:ext cx="220932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50920" y="2907000"/>
            <a:ext cx="4527360" cy="15832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B2F78D-0716-4719-AEC0-0A5AA037CF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50920" y="201600"/>
            <a:ext cx="4527360" cy="83808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50920" y="1172880"/>
            <a:ext cx="4527360" cy="331956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t">
            <a:normAutofit/>
          </a:bodyPr>
          <a:p>
            <a:pPr marL="223920" indent="-22392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487440" indent="-18756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750960" indent="-14940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050840" indent="-14904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351080" indent="-1494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351080" indent="-1494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351080" indent="-1494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50560" y="4660560"/>
            <a:ext cx="1174680" cy="26820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717560" y="4660560"/>
            <a:ext cx="1594080" cy="26820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p>
            <a:pPr indent="0"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603240" y="4660560"/>
            <a:ext cx="1174680" cy="268200"/>
          </a:xfrm>
          <a:prstGeom prst="rect">
            <a:avLst/>
          </a:prstGeom>
          <a:noFill/>
          <a:ln w="0">
            <a:noFill/>
          </a:ln>
        </p:spPr>
        <p:txBody>
          <a:bodyPr lIns="60120" rIns="60120" tIns="29880" bIns="2988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fld id="{19ED337E-BFFB-4662-AC19-5C1FEE64599D}" type="slidenum">
              <a:rPr b="0" lang="en-US" sz="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9"/>
          <p:cNvSpPr/>
          <p:nvPr/>
        </p:nvSpPr>
        <p:spPr>
          <a:xfrm>
            <a:off x="2104920" y="190440"/>
            <a:ext cx="40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KC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30"/>
          <p:cNvGrpSpPr/>
          <p:nvPr/>
        </p:nvGrpSpPr>
        <p:grpSpPr>
          <a:xfrm>
            <a:off x="0" y="-4680"/>
            <a:ext cx="5410080" cy="4140000"/>
            <a:chOff x="0" y="-4680"/>
            <a:chExt cx="5410080" cy="4140000"/>
          </a:xfrm>
        </p:grpSpPr>
        <p:sp>
          <p:nvSpPr>
            <p:cNvPr id="43" name="Rectangle 31"/>
            <p:cNvSpPr/>
            <p:nvPr/>
          </p:nvSpPr>
          <p:spPr>
            <a:xfrm rot="16200000">
              <a:off x="-595800" y="1856880"/>
              <a:ext cx="1468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600120"/>
                  <a:tab algn="l" pos="1200240"/>
                  <a:tab algn="l" pos="1800360"/>
                  <a:tab algn="l" pos="2400480"/>
                  <a:tab algn="l" pos="3000240"/>
                  <a:tab algn="l" pos="3600360"/>
                  <a:tab algn="l" pos="4200480"/>
                  <a:tab algn="l" pos="4800600"/>
                  <a:tab algn="l" pos="5400720"/>
                  <a:tab algn="l" pos="6000840"/>
                  <a:tab algn="l" pos="6600960"/>
                  <a:tab algn="l" pos="7201080"/>
                  <a:tab algn="l" pos="7800840"/>
                  <a:tab algn="l" pos="8400960"/>
                  <a:tab algn="l" pos="9001080"/>
                  <a:tab algn="l" pos="9601200"/>
                  <a:tab algn="l" pos="10201320"/>
                  <a:tab algn="l" pos="1080144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Response (∆F/Fo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Group 12"/>
            <p:cNvGrpSpPr/>
            <p:nvPr/>
          </p:nvGrpSpPr>
          <p:grpSpPr>
            <a:xfrm>
              <a:off x="73080" y="-4680"/>
              <a:ext cx="5337000" cy="4140000"/>
              <a:chOff x="73080" y="-4680"/>
              <a:chExt cx="5337000" cy="4140000"/>
            </a:xfrm>
          </p:grpSpPr>
          <p:pic>
            <p:nvPicPr>
              <p:cNvPr id="45" name="Chart 4" descr=""/>
              <p:cNvPicPr/>
              <p:nvPr/>
            </p:nvPicPr>
            <p:blipFill>
              <a:blip r:embed="rId1"/>
              <a:stretch/>
            </p:blipFill>
            <p:spPr>
              <a:xfrm>
                <a:off x="73080" y="-4680"/>
                <a:ext cx="5337000" cy="4140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Straight Connector 34"/>
              <p:cNvSpPr/>
              <p:nvPr/>
            </p:nvSpPr>
            <p:spPr>
              <a:xfrm>
                <a:off x="747720" y="629640"/>
                <a:ext cx="344376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47" name="TextBox 35"/>
          <p:cNvSpPr/>
          <p:nvPr/>
        </p:nvSpPr>
        <p:spPr>
          <a:xfrm>
            <a:off x="2241720" y="4030560"/>
            <a:ext cx="75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ime (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"/>
          <p:cNvSpPr/>
          <p:nvPr/>
        </p:nvSpPr>
        <p:spPr>
          <a:xfrm>
            <a:off x="380880" y="4492440"/>
            <a:ext cx="4496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3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S/CI (n =18) and MS/CS (n = 20) neurons show similar responses to KCL. KCL (30 mM) was applied for 5 min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37"/>
          <p:cNvSpPr/>
          <p:nvPr/>
        </p:nvSpPr>
        <p:spPr>
          <a:xfrm>
            <a:off x="3386520" y="2678040"/>
            <a:ext cx="740160" cy="52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S/C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600120"/>
                <a:tab algn="l" pos="1200240"/>
                <a:tab algn="l" pos="1800360"/>
                <a:tab algn="l" pos="2400480"/>
                <a:tab algn="l" pos="3000240"/>
                <a:tab algn="l" pos="3600360"/>
                <a:tab algn="l" pos="4200480"/>
                <a:tab algn="l" pos="4800600"/>
                <a:tab algn="l" pos="5400720"/>
                <a:tab algn="l" pos="6000840"/>
                <a:tab algn="l" pos="6600960"/>
                <a:tab algn="l" pos="7201080"/>
                <a:tab algn="l" pos="7800840"/>
                <a:tab algn="l" pos="8400960"/>
                <a:tab algn="l" pos="9001080"/>
                <a:tab algn="l" pos="9601200"/>
                <a:tab algn="l" pos="10201320"/>
                <a:tab algn="l" pos="108014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S/CS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28T13:35:38Z</dcterms:created>
  <dc:creator>Jianguo Gu</dc:creator>
  <dc:description/>
  <dc:language>en-US</dc:language>
  <cp:lastModifiedBy>sarriaio</cp:lastModifiedBy>
  <dcterms:modified xsi:type="dcterms:W3CDTF">2010-08-11T17:03:21Z</dcterms:modified>
  <cp:revision>5</cp:revision>
  <dc:subject/>
  <dc:title>Slide 1</dc:title>
</cp:coreProperties>
</file>